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653" y="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A53179-8A62-4227-9965-6C296251BF21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232662-5CDB-4B02-852A-82DC54809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619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.S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232662-5CDB-4B02-852A-82DC548096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7103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B24BA5-9DF3-4E1C-8C8F-F04BF87852C4}" type="datetimeFigureOut">
              <a:rPr lang="en-US" smtClean="0"/>
              <a:t>9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B09C5-E0B8-40DE-8DF0-3B1210F1EAC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Рисунок 2" descr="Изображение выглядит как темный, ночь, звезда, наружный объект&#10;&#10;Автоматически созданное описание">
            <a:extLst>
              <a:ext uri="{FF2B5EF4-FFF2-40B4-BE49-F238E27FC236}">
                <a16:creationId xmlns:a16="http://schemas.microsoft.com/office/drawing/2014/main" id="{5CB49679-9A46-4FDA-AE80-653788CE30B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152400"/>
            <a:ext cx="2819400" cy="2971799"/>
          </a:xfrm>
          <a:prstGeom prst="rect">
            <a:avLst/>
          </a:prstGeom>
        </p:spPr>
      </p:pic>
      <p:pic>
        <p:nvPicPr>
          <p:cNvPr id="5" name="Рисунок 4" descr="Изображение выглядит как дерево, внешний, зеленый,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06C2850F-9805-410B-BFC9-C30565BC2FC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0400" y="152400"/>
            <a:ext cx="2819400" cy="2971799"/>
          </a:xfrm>
          <a:prstGeom prst="rect">
            <a:avLst/>
          </a:prstGeom>
        </p:spPr>
      </p:pic>
      <p:pic>
        <p:nvPicPr>
          <p:cNvPr id="7" name="Рисунок 6" descr="Изображение выглядит как наружный объект, звезда&#10;&#10;Автоматически созданное описание">
            <a:extLst>
              <a:ext uri="{FF2B5EF4-FFF2-40B4-BE49-F238E27FC236}">
                <a16:creationId xmlns:a16="http://schemas.microsoft.com/office/drawing/2014/main" id="{3FFA764C-BF07-4077-81AC-CE176181A15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52400"/>
            <a:ext cx="2819400" cy="297179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E7FD974-F922-474B-983F-C015E607A7B3}"/>
              </a:ext>
            </a:extLst>
          </p:cNvPr>
          <p:cNvSpPr txBox="1"/>
          <p:nvPr/>
        </p:nvSpPr>
        <p:spPr>
          <a:xfrm>
            <a:off x="6096000" y="3237028"/>
            <a:ext cx="29718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.S2</a:t>
            </a:r>
          </a:p>
          <a:p>
            <a:r>
              <a:rPr lang="en-US" sz="1200" dirty="0" smtClean="0"/>
              <a:t>A.  DAPI excessive fluorescence (A1 blue) concentrated near the blood vessel in the tumor and partially coincide with beta-amyloid Ab1-42 </a:t>
            </a:r>
            <a:r>
              <a:rPr lang="en-US" sz="1200" dirty="0"/>
              <a:t>antibody </a:t>
            </a:r>
            <a:r>
              <a:rPr lang="en-US" sz="1200" dirty="0" smtClean="0"/>
              <a:t>fluorescence (</a:t>
            </a:r>
            <a:r>
              <a:rPr lang="en-US" sz="1200" dirty="0"/>
              <a:t>A2 </a:t>
            </a:r>
            <a:r>
              <a:rPr lang="en-US" sz="1200" dirty="0" smtClean="0"/>
              <a:t>green)that is marking carcinoma cells. </a:t>
            </a:r>
          </a:p>
          <a:p>
            <a:endParaRPr lang="en-US" sz="1200" dirty="0" smtClean="0"/>
          </a:p>
          <a:p>
            <a:r>
              <a:rPr lang="en-US" sz="1200" dirty="0" smtClean="0"/>
              <a:t>B.  DAPI excessive fluorescence (B1 blue) partially  coincide with MOAB-2 anti-Ab-antibody  immunofluorescence (B2 red) that is marking carcinoma cells.</a:t>
            </a:r>
          </a:p>
          <a:p>
            <a:r>
              <a:rPr lang="en-US" sz="1200" dirty="0" smtClean="0"/>
              <a:t> </a:t>
            </a:r>
            <a:endParaRPr lang="en-US" sz="1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8636" y="3237028"/>
            <a:ext cx="2835564" cy="297179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00401" y="3237028"/>
            <a:ext cx="2819399" cy="297179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81000" y="228599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</a:rPr>
              <a:t>A1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331590" y="228599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</a:rPr>
              <a:t>A2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172200" y="228600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</a:rPr>
              <a:t>A3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78001" y="3320901"/>
            <a:ext cx="513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</a:rPr>
              <a:t>B1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07238" y="3323567"/>
            <a:ext cx="513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</a:rPr>
              <a:t>B2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533360" y="2895600"/>
            <a:ext cx="457200" cy="457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533360" y="6016757"/>
            <a:ext cx="457240" cy="4571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3</TotalTime>
  <Words>67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indows User</dc:creator>
  <cp:lastModifiedBy>Dr. Mikhail Inyushin</cp:lastModifiedBy>
  <cp:revision>60</cp:revision>
  <dcterms:created xsi:type="dcterms:W3CDTF">2021-03-06T12:13:34Z</dcterms:created>
  <dcterms:modified xsi:type="dcterms:W3CDTF">2021-09-22T18:57:52Z</dcterms:modified>
</cp:coreProperties>
</file>